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93" r:id="rId2"/>
    <p:sldId id="294" r:id="rId3"/>
    <p:sldId id="295" r:id="rId4"/>
    <p:sldId id="296" r:id="rId5"/>
    <p:sldId id="297" r:id="rId6"/>
    <p:sldId id="298" r:id="rId7"/>
    <p:sldId id="299" r:id="rId8"/>
    <p:sldId id="301" r:id="rId9"/>
    <p:sldId id="302" r:id="rId10"/>
    <p:sldId id="300" r:id="rId11"/>
    <p:sldId id="303" r:id="rId12"/>
    <p:sldId id="304" r:id="rId13"/>
    <p:sldId id="305" r:id="rId14"/>
    <p:sldId id="306" r:id="rId15"/>
    <p:sldId id="307" r:id="rId16"/>
    <p:sldId id="308" r:id="rId17"/>
    <p:sldId id="309" r:id="rId18"/>
    <p:sldId id="310" r:id="rId19"/>
  </p:sldIdLst>
  <p:sldSz cx="12192000" cy="6858000"/>
  <p:notesSz cx="6858000" cy="9144000"/>
  <p:custDataLst>
    <p:tags r:id="rId20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376" y="56"/>
      </p:cViewPr>
      <p:guideLst>
        <p:guide orient="horz" pos="2160"/>
        <p:guide pos="384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presProps" Target="presProps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tags" Target="tags/tag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ableStyles" Target="tableStyle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theme" Target="theme/theme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5/9/19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5/9/19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9A8C0FB-5650-5C3A-2B7D-6BD57834048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2352" y="686972"/>
            <a:ext cx="5785605" cy="565148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C5543EEA-32E3-B4CF-B714-5F998FDF44DA}"/>
              </a:ext>
            </a:extLst>
          </p:cNvPr>
          <p:cNvSpPr txBox="1"/>
          <p:nvPr/>
        </p:nvSpPr>
        <p:spPr>
          <a:xfrm>
            <a:off x="7830355" y="6059510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1J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66956660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3FC55F89-CCCB-ECE9-FE63-C93B019E41EB}"/>
              </a:ext>
            </a:extLst>
          </p:cNvPr>
          <p:cNvSpPr txBox="1"/>
          <p:nvPr/>
        </p:nvSpPr>
        <p:spPr>
          <a:xfrm>
            <a:off x="10811815" y="635344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D</a:t>
            </a:r>
            <a:endParaRPr lang="zh-CN" altLang="en-US" dirty="0"/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F34F397-2F1F-904D-ADA5-B97226CD094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9561" y="1920721"/>
            <a:ext cx="5011346" cy="1780186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0681BB8C-5ECA-8BDB-600B-D7938677BCB8}"/>
              </a:ext>
            </a:extLst>
          </p:cNvPr>
          <p:cNvSpPr txBox="1"/>
          <p:nvPr/>
        </p:nvSpPr>
        <p:spPr>
          <a:xfrm>
            <a:off x="3427135" y="3700907"/>
            <a:ext cx="47641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13" dirty="0"/>
              <a:t>Input</a:t>
            </a:r>
            <a:endParaRPr lang="zh-CN" altLang="en-US" sz="1013" dirty="0"/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FF785B74-DF55-9537-35A5-F7955D88F37B}"/>
              </a:ext>
            </a:extLst>
          </p:cNvPr>
          <p:cNvSpPr txBox="1"/>
          <p:nvPr/>
        </p:nvSpPr>
        <p:spPr>
          <a:xfrm>
            <a:off x="3801311" y="3696209"/>
            <a:ext cx="38023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13" dirty="0"/>
              <a:t>IgG</a:t>
            </a:r>
            <a:endParaRPr lang="zh-CN" altLang="en-US" sz="1013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01FDB126-AB7F-7365-9D1F-12987D24F301}"/>
              </a:ext>
            </a:extLst>
          </p:cNvPr>
          <p:cNvSpPr txBox="1"/>
          <p:nvPr/>
        </p:nvSpPr>
        <p:spPr>
          <a:xfrm>
            <a:off x="4098828" y="3669844"/>
            <a:ext cx="35779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13" dirty="0"/>
              <a:t>HA</a:t>
            </a:r>
            <a:endParaRPr lang="zh-CN" altLang="en-US" sz="1013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B8C986A8-605A-2866-9B5F-0EFD8F94AB92}"/>
              </a:ext>
            </a:extLst>
          </p:cNvPr>
          <p:cNvSpPr txBox="1"/>
          <p:nvPr/>
        </p:nvSpPr>
        <p:spPr>
          <a:xfrm>
            <a:off x="5594192" y="3730755"/>
            <a:ext cx="47641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13" dirty="0"/>
              <a:t>Input</a:t>
            </a:r>
            <a:endParaRPr lang="zh-CN" altLang="en-US" sz="1013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EA28619-3309-67E2-4948-1CF92F2AC46E}"/>
              </a:ext>
            </a:extLst>
          </p:cNvPr>
          <p:cNvSpPr txBox="1"/>
          <p:nvPr/>
        </p:nvSpPr>
        <p:spPr>
          <a:xfrm>
            <a:off x="5968368" y="3726057"/>
            <a:ext cx="380232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13" dirty="0"/>
              <a:t>IgG</a:t>
            </a:r>
            <a:endParaRPr lang="zh-CN" altLang="en-US" sz="1013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44C0FD9C-4009-5359-C441-022F9BD815DC}"/>
              </a:ext>
            </a:extLst>
          </p:cNvPr>
          <p:cNvSpPr txBox="1"/>
          <p:nvPr/>
        </p:nvSpPr>
        <p:spPr>
          <a:xfrm>
            <a:off x="6265885" y="3699692"/>
            <a:ext cx="357790" cy="24820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013" dirty="0"/>
              <a:t>HA</a:t>
            </a:r>
            <a:endParaRPr lang="zh-CN" altLang="en-US" sz="1013" dirty="0"/>
          </a:p>
        </p:txBody>
      </p:sp>
    </p:spTree>
    <p:extLst>
      <p:ext uri="{BB962C8B-B14F-4D97-AF65-F5344CB8AC3E}">
        <p14:creationId xmlns:p14="http://schemas.microsoft.com/office/powerpoint/2010/main" val="309745900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E98BA0A-A626-A72E-6528-78498C928C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5384" y="974778"/>
            <a:ext cx="3029975" cy="512108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1835E4B-8AF2-E5F2-71ED-66AD7F22E1AC}"/>
              </a:ext>
            </a:extLst>
          </p:cNvPr>
          <p:cNvSpPr txBox="1"/>
          <p:nvPr/>
        </p:nvSpPr>
        <p:spPr>
          <a:xfrm>
            <a:off x="2524260" y="6256848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E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6A5B8430-E7E8-FCC5-FEFC-76A60F518A1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096000" y="724820"/>
            <a:ext cx="3785944" cy="5620999"/>
          </a:xfrm>
          <a:prstGeom prst="rect">
            <a:avLst/>
          </a:prstGeom>
        </p:spPr>
      </p:pic>
      <p:sp>
        <p:nvSpPr>
          <p:cNvPr id="5" name="文本框 4">
            <a:extLst>
              <a:ext uri="{FF2B5EF4-FFF2-40B4-BE49-F238E27FC236}">
                <a16:creationId xmlns:a16="http://schemas.microsoft.com/office/drawing/2014/main" id="{B915A689-2885-35BB-4D9D-F78EFA2691B9}"/>
              </a:ext>
            </a:extLst>
          </p:cNvPr>
          <p:cNvSpPr txBox="1"/>
          <p:nvPr/>
        </p:nvSpPr>
        <p:spPr>
          <a:xfrm>
            <a:off x="8285409" y="6441514"/>
            <a:ext cx="7745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F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22407759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55330E10-CA49-1D73-D36E-666F09630EF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51207" y="892844"/>
            <a:ext cx="3889585" cy="507231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4B056F3-71F4-2533-E6F9-0B9818B68D8A}"/>
              </a:ext>
            </a:extLst>
          </p:cNvPr>
          <p:cNvSpPr txBox="1"/>
          <p:nvPr/>
        </p:nvSpPr>
        <p:spPr>
          <a:xfrm>
            <a:off x="10064839" y="6381482"/>
            <a:ext cx="7617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6I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97702906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C1BE6CE-FEA4-F05E-0580-9C44255673E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85415" y="1258636"/>
            <a:ext cx="4621169" cy="434072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C5A2BF84-DD49-A483-1472-9151644BE10F}"/>
              </a:ext>
            </a:extLst>
          </p:cNvPr>
          <p:cNvSpPr txBox="1"/>
          <p:nvPr/>
        </p:nvSpPr>
        <p:spPr>
          <a:xfrm>
            <a:off x="10064839" y="638148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6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8890312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526A9B4-9320-8AEB-101E-AF3FE236E79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47566" y="740431"/>
            <a:ext cx="4096867" cy="537713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FA8F784-BB03-8C7E-8389-A2B17FF31157}"/>
              </a:ext>
            </a:extLst>
          </p:cNvPr>
          <p:cNvSpPr txBox="1"/>
          <p:nvPr/>
        </p:nvSpPr>
        <p:spPr>
          <a:xfrm>
            <a:off x="10064839" y="6381482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7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4111991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B18BC79-728A-E1AB-F505-7F680BF67B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71360" y="1176333"/>
            <a:ext cx="4249280" cy="450533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921FC1E4-B515-6BCF-24B1-D4C2C9467496}"/>
              </a:ext>
            </a:extLst>
          </p:cNvPr>
          <p:cNvSpPr txBox="1"/>
          <p:nvPr/>
        </p:nvSpPr>
        <p:spPr>
          <a:xfrm>
            <a:off x="10064839" y="6381482"/>
            <a:ext cx="8515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7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03902448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63A1026-B11F-D516-0D30-E8A876011D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28684" y="249660"/>
            <a:ext cx="4334632" cy="6358679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F7BA9D50-F15D-CAEE-D85E-11FCFED7F504}"/>
              </a:ext>
            </a:extLst>
          </p:cNvPr>
          <p:cNvSpPr txBox="1"/>
          <p:nvPr/>
        </p:nvSpPr>
        <p:spPr>
          <a:xfrm>
            <a:off x="10064839" y="6381482"/>
            <a:ext cx="86433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7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8659063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889CD396-39DC-AB00-B9DF-AA1C945A2E0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5148" y="483762"/>
            <a:ext cx="3214501" cy="5890476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327ED17F-6435-C9BA-B801-ACABFD2545BB}"/>
              </a:ext>
            </a:extLst>
          </p:cNvPr>
          <p:cNvSpPr txBox="1"/>
          <p:nvPr/>
        </p:nvSpPr>
        <p:spPr>
          <a:xfrm>
            <a:off x="10064839" y="6381482"/>
            <a:ext cx="9925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6F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294959725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2F55BB4-3942-37E5-60B5-2E7143088B3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8726" y="450846"/>
            <a:ext cx="4834547" cy="5956308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4A6C9BD-F338-D3A3-C491-0115DC706870}"/>
              </a:ext>
            </a:extLst>
          </p:cNvPr>
          <p:cNvSpPr txBox="1"/>
          <p:nvPr/>
        </p:nvSpPr>
        <p:spPr>
          <a:xfrm>
            <a:off x="10064839" y="6381482"/>
            <a:ext cx="1031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.S6G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304637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47A7AD9-7955-C681-28AB-016CF7EA53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41799" y="202146"/>
            <a:ext cx="6181880" cy="6157494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BC539D87-1CB3-E825-2FA2-8272B072731B}"/>
              </a:ext>
            </a:extLst>
          </p:cNvPr>
          <p:cNvSpPr txBox="1"/>
          <p:nvPr/>
        </p:nvSpPr>
        <p:spPr>
          <a:xfrm>
            <a:off x="10856891" y="6488668"/>
            <a:ext cx="74892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1J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1911588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E8C7D39-2D68-5C9A-C884-F4105098F26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20040" y="1438483"/>
            <a:ext cx="7011008" cy="3981033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8845C35F-1F0A-A96A-A8C8-C19075C16139}"/>
              </a:ext>
            </a:extLst>
          </p:cNvPr>
          <p:cNvSpPr txBox="1"/>
          <p:nvPr/>
        </p:nvSpPr>
        <p:spPr>
          <a:xfrm>
            <a:off x="10811815" y="6353440"/>
            <a:ext cx="10182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2A-B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3897083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845F78A-1927-9C00-4F89-F910BBD24E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92274" y="1475062"/>
            <a:ext cx="6407451" cy="390787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66BDE905-F935-B7B4-ECD0-1E7402B684A2}"/>
              </a:ext>
            </a:extLst>
          </p:cNvPr>
          <p:cNvSpPr txBox="1"/>
          <p:nvPr/>
        </p:nvSpPr>
        <p:spPr>
          <a:xfrm>
            <a:off x="10811815" y="635344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2E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71840299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7C0BB31-EC95-6ECB-620F-61AD209FB6F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8633" y="1837806"/>
            <a:ext cx="6614733" cy="3182388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BA337C0E-E1A5-282E-9116-D2DAA8147C5D}"/>
              </a:ext>
            </a:extLst>
          </p:cNvPr>
          <p:cNvSpPr txBox="1"/>
          <p:nvPr/>
        </p:nvSpPr>
        <p:spPr>
          <a:xfrm>
            <a:off x="10811815" y="635344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2H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7885259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C1F9876D-B1DA-23C8-C6CD-9ADF2F2BFA2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126990" y="1005630"/>
            <a:ext cx="5938019" cy="4846740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799BC4D1-F61F-C49B-27CE-F24D141E9F08}"/>
              </a:ext>
            </a:extLst>
          </p:cNvPr>
          <p:cNvSpPr txBox="1"/>
          <p:nvPr/>
        </p:nvSpPr>
        <p:spPr>
          <a:xfrm>
            <a:off x="10811815" y="635344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2I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536252520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7D3649E5-F90B-995F-3B4C-925F045786C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00812" y="1825613"/>
            <a:ext cx="4535817" cy="3206774"/>
          </a:xfrm>
          <a:prstGeom prst="rect">
            <a:avLst/>
          </a:prstGeom>
        </p:spPr>
      </p:pic>
      <p:sp>
        <p:nvSpPr>
          <p:cNvPr id="12" name="文本框 11">
            <a:extLst>
              <a:ext uri="{FF2B5EF4-FFF2-40B4-BE49-F238E27FC236}">
                <a16:creationId xmlns:a16="http://schemas.microsoft.com/office/drawing/2014/main" id="{A0DB4C9A-799B-CA90-195A-C944092C4D75}"/>
              </a:ext>
            </a:extLst>
          </p:cNvPr>
          <p:cNvSpPr txBox="1"/>
          <p:nvPr/>
        </p:nvSpPr>
        <p:spPr>
          <a:xfrm>
            <a:off x="10811815" y="6353440"/>
            <a:ext cx="80021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4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4618044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A81E94FB-F7D1-E747-85FB-5192A62ED0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9548" y="603259"/>
            <a:ext cx="8772904" cy="5651482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DC17C0D2-FD19-5996-CB90-56459D4B869E}"/>
              </a:ext>
            </a:extLst>
          </p:cNvPr>
          <p:cNvSpPr txBox="1"/>
          <p:nvPr/>
        </p:nvSpPr>
        <p:spPr>
          <a:xfrm>
            <a:off x="10811815" y="635344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67920101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3BA6A2D6-453A-9BD9-4758-9409301F7B6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249260" y="1325697"/>
            <a:ext cx="9693480" cy="4206605"/>
          </a:xfrm>
          <a:prstGeom prst="rect">
            <a:avLst/>
          </a:prstGeom>
        </p:spPr>
      </p:pic>
      <p:sp>
        <p:nvSpPr>
          <p:cNvPr id="3" name="文本框 2">
            <a:extLst>
              <a:ext uri="{FF2B5EF4-FFF2-40B4-BE49-F238E27FC236}">
                <a16:creationId xmlns:a16="http://schemas.microsoft.com/office/drawing/2014/main" id="{150EB3BA-FDB8-0B2F-1760-FE8ECA5FC341}"/>
              </a:ext>
            </a:extLst>
          </p:cNvPr>
          <p:cNvSpPr txBox="1"/>
          <p:nvPr/>
        </p:nvSpPr>
        <p:spPr>
          <a:xfrm>
            <a:off x="10811815" y="6353440"/>
            <a:ext cx="7873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5A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8818378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N2M5ZWYxZmQ4ZTQ1OTg1OWQxNTdmYjEwNzkzMDZhOTQ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49</TotalTime>
  <Words>39</Words>
  <Application>Microsoft Office PowerPoint</Application>
  <PresentationFormat>宽屏</PresentationFormat>
  <Paragraphs>25</Paragraphs>
  <Slides>1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2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8</vt:i4>
      </vt:variant>
    </vt:vector>
  </HeadingPairs>
  <TitlesOfParts>
    <vt:vector size="21" baseType="lpstr">
      <vt:lpstr>Arial</vt:lpstr>
      <vt:lpstr>Wingding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刘改霞</dc:creator>
  <cp:lastModifiedBy>改霞 刘</cp:lastModifiedBy>
  <cp:revision>182</cp:revision>
  <dcterms:created xsi:type="dcterms:W3CDTF">2019-06-19T02:08:00Z</dcterms:created>
  <dcterms:modified xsi:type="dcterms:W3CDTF">2025-09-19T05:42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120</vt:lpwstr>
  </property>
  <property fmtid="{D5CDD505-2E9C-101B-9397-08002B2CF9AE}" pid="3" name="ICV">
    <vt:lpwstr>762105A74C3A42B7AE163CB8300CB451_13</vt:lpwstr>
  </property>
</Properties>
</file>